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40"/>
    <p:restoredTop sz="94595"/>
  </p:normalViewPr>
  <p:slideViewPr>
    <p:cSldViewPr snapToGrid="0" snapToObjects="1">
      <p:cViewPr varScale="1">
        <p:scale>
          <a:sx n="76" d="100"/>
          <a:sy n="76" d="100"/>
        </p:scale>
        <p:origin x="288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81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87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214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913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5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554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49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33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177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3265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CDB7-434D-7A41-8468-D5675991FA54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94E98-E8BF-5640-AF76-7FE5C2D2EA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298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377161" y="607896"/>
            <a:ext cx="4114800" cy="384048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9370" y="278296"/>
            <a:ext cx="1653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charset="0"/>
                <a:ea typeface="Arial" charset="0"/>
                <a:cs typeface="Arial" charset="0"/>
              </a:rPr>
              <a:t>Figure 3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369912" y="4012874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3297788" y="4007578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0.5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4215730" y="400909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5127299" y="400909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1.5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6033909" y="4009092"/>
            <a:ext cx="564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2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2679567" y="4260464"/>
            <a:ext cx="36468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YM155 IC</a:t>
            </a:r>
            <a:r>
              <a:rPr lang="en-GB" sz="1200" baseline="-25000" dirty="0">
                <a:latin typeface="Arial" charset="0"/>
                <a:ea typeface="Arial" charset="0"/>
                <a:cs typeface="Arial" charset="0"/>
              </a:rPr>
              <a:t>50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GB" sz="1200" dirty="0" err="1">
                <a:latin typeface="Arial" charset="0"/>
                <a:ea typeface="Arial" charset="0"/>
                <a:cs typeface="Arial" charset="0"/>
              </a:rPr>
              <a:t>n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21000" y="3799430"/>
            <a:ext cx="217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6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IV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24538" y="3622217"/>
            <a:ext cx="217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6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I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28081" y="3434366"/>
            <a:ext cx="217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6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31623" y="3267781"/>
            <a:ext cx="217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6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524543" y="3090591"/>
            <a:ext cx="217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3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X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74432" y="2902743"/>
            <a:ext cx="2623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3r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X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7974" y="2725524"/>
            <a:ext cx="2623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3r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III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81516" y="2558944"/>
            <a:ext cx="2623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3r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I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85058" y="2371095"/>
            <a:ext cx="2623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3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28085" y="2190360"/>
            <a:ext cx="2173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clone1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X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4432" y="2023773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1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III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77975" y="1846555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clone1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VI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81518" y="1669336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clone1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IV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85061" y="1492118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clone1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III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88604" y="1325533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clone1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>
                <a:latin typeface="Arial" charset="0"/>
                <a:ea typeface="Arial" charset="0"/>
                <a:cs typeface="Arial" charset="0"/>
              </a:rPr>
              <a:t>10µM</a:t>
            </a:r>
            <a:r>
              <a:rPr lang="en-GB" sz="1200">
                <a:latin typeface="Arial" charset="0"/>
                <a:ea typeface="Arial" charset="0"/>
                <a:cs typeface="Arial" charset="0"/>
              </a:rPr>
              <a:t>I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92146" y="1137681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>
                <a:latin typeface="Arial" charset="0"/>
                <a:ea typeface="Arial" charset="0"/>
                <a:cs typeface="Arial" charset="0"/>
              </a:rPr>
              <a:t>UKF-NB-3clone1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95688" y="790339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92146" y="956932"/>
            <a:ext cx="263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dirty="0">
                <a:latin typeface="Arial" charset="0"/>
                <a:ea typeface="Arial" charset="0"/>
                <a:cs typeface="Arial" charset="0"/>
              </a:rPr>
              <a:t>UKF-NB-3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GB" sz="1200" dirty="0">
                <a:latin typeface="Arial" charset="0"/>
                <a:ea typeface="Arial" charset="0"/>
                <a:cs typeface="Arial" charset="0"/>
              </a:rPr>
              <a:t>Nutlin</a:t>
            </a:r>
            <a:r>
              <a:rPr lang="en-GB" sz="1200" baseline="30000" dirty="0">
                <a:latin typeface="Arial" charset="0"/>
                <a:ea typeface="Arial" charset="0"/>
                <a:cs typeface="Arial" charset="0"/>
              </a:rPr>
              <a:t>10µM</a:t>
            </a:r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506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6</TotalTime>
  <Words>30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ichaelis</dc:creator>
  <cp:lastModifiedBy>Microsoft Office User</cp:lastModifiedBy>
  <cp:revision>78</cp:revision>
  <dcterms:created xsi:type="dcterms:W3CDTF">2016-10-07T17:18:31Z</dcterms:created>
  <dcterms:modified xsi:type="dcterms:W3CDTF">2020-02-20T21:05:41Z</dcterms:modified>
</cp:coreProperties>
</file>